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2" r:id="rId2"/>
    <p:sldId id="256" r:id="rId3"/>
    <p:sldId id="257" r:id="rId4"/>
    <p:sldId id="258" r:id="rId5"/>
    <p:sldId id="265" r:id="rId6"/>
    <p:sldId id="266" r:id="rId7"/>
    <p:sldId id="267" r:id="rId8"/>
    <p:sldId id="268" r:id="rId9"/>
    <p:sldId id="270" r:id="rId10"/>
    <p:sldId id="271" r:id="rId11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79378" autoAdjust="0"/>
  </p:normalViewPr>
  <p:slideViewPr>
    <p:cSldViewPr showGuides="1">
      <p:cViewPr>
        <p:scale>
          <a:sx n="80" d="100"/>
          <a:sy n="80" d="100"/>
        </p:scale>
        <p:origin x="-1522" y="-350"/>
      </p:cViewPr>
      <p:guideLst>
        <p:guide orient="horz" pos="2795"/>
        <p:guide orient="horz" pos="754"/>
        <p:guide pos="2880"/>
        <p:guide pos="2699"/>
        <p:guide pos="310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DB345A-F760-459D-BFA2-A800377CCEE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5F28D6-5A6A-4E25-9AB4-2EDAFBB6D0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0739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5F28D6-5A6A-4E25-9AB4-2EDAFBB6D0F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08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A043D-D798-4A8D-9C0A-721F516E1084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D5AF2-FF51-46BC-AD87-0348B5126F7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71600" y="764704"/>
            <a:ext cx="7416824" cy="5324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2000" b="1" cap="all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ko-KR" sz="2000" b="1" cap="all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en-US" altLang="ko-KR" sz="2000" b="1" cap="all" dirty="0" smtClean="0">
                <a:latin typeface="Times New Roman" pitchFamily="18" charset="0"/>
                <a:cs typeface="Times New Roman" pitchFamily="18" charset="0"/>
              </a:rPr>
              <a:t>legend</a:t>
            </a:r>
            <a:endParaRPr lang="ko-KR" altLang="ko-KR" sz="2000" dirty="0" smtClean="0">
              <a:latin typeface="Times New Roman" pitchFamily="18" charset="0"/>
              <a:cs typeface="Times New Roman" pitchFamily="18" charset="0"/>
            </a:endParaRPr>
          </a:p>
          <a:p>
            <a:pPr latinLnBrk="0"/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ko-KR" altLang="ko-KR" sz="2000" dirty="0" smtClean="0">
              <a:latin typeface="Times New Roman" pitchFamily="18" charset="0"/>
              <a:cs typeface="Times New Roman" pitchFamily="18" charset="0"/>
            </a:endParaRPr>
          </a:p>
          <a:p>
            <a:pPr latinLnBrk="0"/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. Scatter plots of MRM quantitation data using pooling serum and individual serum from healthy control group,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before HCC treatment group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after 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HCC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treatment group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. </a:t>
            </a:r>
            <a:endParaRPr lang="en-US" altLang="ko-KR" sz="2000" b="1" dirty="0" smtClean="0">
              <a:latin typeface="Times New Roman" pitchFamily="18" charset="0"/>
              <a:cs typeface="Times New Roman" pitchFamily="18" charset="0"/>
            </a:endParaRPr>
          </a:p>
          <a:p>
            <a:pPr latinLnBrk="0"/>
            <a:endParaRPr lang="ko-KR" altLang="ko-KR" sz="2000" dirty="0">
              <a:latin typeface="Times New Roman" pitchFamily="18" charset="0"/>
              <a:cs typeface="Times New Roman" pitchFamily="18" charset="0"/>
            </a:endParaRPr>
          </a:p>
          <a:p>
            <a:pPr latinLnBrk="0"/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Left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panel represents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pooled serum from healthy control group, before HCC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treatment group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, and after HCC treatment group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rror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bars represent the standard deviations from 5 technical replicates. Horizontal bars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indicate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the average serum level of the protein; </a:t>
            </a:r>
            <a:r>
              <a:rPr lang="en-US" altLang="ko-KR" sz="20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-values were calculated by ANOVA. </a:t>
            </a:r>
            <a:endParaRPr lang="en-US" altLang="ko-KR" sz="2000" dirty="0" smtClean="0">
              <a:latin typeface="Times New Roman" pitchFamily="18" charset="0"/>
              <a:cs typeface="Times New Roman" pitchFamily="18" charset="0"/>
            </a:endParaRPr>
          </a:p>
          <a:p>
            <a:pPr latinLnBrk="0"/>
            <a:endParaRPr lang="en-US" altLang="ko-KR" sz="2000" dirty="0">
              <a:latin typeface="Times New Roman" pitchFamily="18" charset="0"/>
              <a:cs typeface="Times New Roman" pitchFamily="18" charset="0"/>
            </a:endParaRPr>
          </a:p>
          <a:p>
            <a:pPr latinLnBrk="0"/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ight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panels indicate individual samples. </a:t>
            </a:r>
            <a:endParaRPr lang="en-US" altLang="ko-KR" sz="2000" dirty="0" smtClean="0">
              <a:latin typeface="Times New Roman" pitchFamily="18" charset="0"/>
              <a:cs typeface="Times New Roman" pitchFamily="18" charset="0"/>
            </a:endParaRPr>
          </a:p>
          <a:p>
            <a:pPr latinLnBrk="0"/>
            <a:endParaRPr lang="en-US" altLang="ko-KR" sz="2000" dirty="0">
              <a:latin typeface="Times New Roman" pitchFamily="18" charset="0"/>
              <a:cs typeface="Times New Roman" pitchFamily="18" charset="0"/>
            </a:endParaRPr>
          </a:p>
          <a:p>
            <a:pPr latinLnBrk="0"/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See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also Supplementary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Table 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S4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and Supplementary Figure 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S2</a:t>
            </a:r>
            <a:endParaRPr lang="ko-KR" altLang="ko-KR" sz="2000" dirty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42819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618" y="10120"/>
            <a:ext cx="75713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9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Polyadenylate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-binding protein 1 (PABPC1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		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7554592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FSPFGTITSA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.3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73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6.8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3.21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2.3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4577356"/>
              </p:ext>
            </p:extLst>
          </p:nvPr>
        </p:nvGraphicFramePr>
        <p:xfrm>
          <a:off x="357158" y="5734061"/>
          <a:ext cx="3926810" cy="733425"/>
        </p:xfrm>
        <a:graphic>
          <a:graphicData uri="http://schemas.openxmlformats.org/drawingml/2006/table">
            <a:tbl>
              <a:tblPr/>
              <a:tblGrid>
                <a:gridCol w="1050929"/>
                <a:gridCol w="34925"/>
                <a:gridCol w="1328788"/>
                <a:gridCol w="1512168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.6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1573585"/>
              </p:ext>
            </p:extLst>
          </p:nvPr>
        </p:nvGraphicFramePr>
        <p:xfrm>
          <a:off x="4832474" y="4143380"/>
          <a:ext cx="4063006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208694"/>
                <a:gridCol w="1035020"/>
                <a:gridCol w="1134048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FSPFGTITSA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8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5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4.4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3.5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4.4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8999684"/>
              </p:ext>
            </p:extLst>
          </p:nvPr>
        </p:nvGraphicFramePr>
        <p:xfrm>
          <a:off x="4832475" y="5757869"/>
          <a:ext cx="4063005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38237"/>
                <a:gridCol w="1224136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No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9397" y="860985"/>
            <a:ext cx="4156185" cy="31171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64" y="853380"/>
            <a:ext cx="4176464" cy="3132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9892" y="3694382"/>
            <a:ext cx="3708313" cy="41237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9598" y="3706758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706759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2201931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642" y="1016651"/>
            <a:ext cx="4250636" cy="31879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0654701"/>
              </p:ext>
            </p:extLst>
          </p:nvPr>
        </p:nvGraphicFramePr>
        <p:xfrm>
          <a:off x="357158" y="432332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AQAPSSFQLLYDL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8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.8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.4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8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2.4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3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9.88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9900197"/>
              </p:ext>
            </p:extLst>
          </p:nvPr>
        </p:nvGraphicFramePr>
        <p:xfrm>
          <a:off x="357158" y="5914001"/>
          <a:ext cx="3926810" cy="733425"/>
        </p:xfrm>
        <a:graphic>
          <a:graphicData uri="http://schemas.openxmlformats.org/drawingml/2006/table">
            <a:tbl>
              <a:tblPr/>
              <a:tblGrid>
                <a:gridCol w="1050929"/>
                <a:gridCol w="34925"/>
                <a:gridCol w="1328788"/>
                <a:gridCol w="1512168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5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9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-32" y="436468"/>
            <a:ext cx="914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1. Very long-chain specific acyl-CoA dehydrogenase, mitochondria (ACADVL)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9" name="표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1398248"/>
              </p:ext>
            </p:extLst>
          </p:nvPr>
        </p:nvGraphicFramePr>
        <p:xfrm>
          <a:off x="4901482" y="4323320"/>
          <a:ext cx="3990998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208694"/>
                <a:gridCol w="1035020"/>
                <a:gridCol w="106204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AQAPSSFQLLYDL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1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20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3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3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6.4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2.94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2.65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0" name="표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172669"/>
              </p:ext>
            </p:extLst>
          </p:nvPr>
        </p:nvGraphicFramePr>
        <p:xfrm>
          <a:off x="4901483" y="5937809"/>
          <a:ext cx="4082869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57313"/>
                <a:gridCol w="1224924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26" name="직사각형 25"/>
          <p:cNvSpPr/>
          <p:nvPr/>
        </p:nvSpPr>
        <p:spPr>
          <a:xfrm>
            <a:off x="142844" y="89429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직사각형 26"/>
          <p:cNvSpPr/>
          <p:nvPr/>
        </p:nvSpPr>
        <p:spPr>
          <a:xfrm>
            <a:off x="4714876" y="89429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1500166" y="75142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000760" y="75142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886" y="1017035"/>
            <a:ext cx="4249612" cy="3187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994" y="3885824"/>
            <a:ext cx="3708313" cy="41237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22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907247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23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907246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sp>
        <p:nvSpPr>
          <p:cNvPr id="3" name="직사각형 2"/>
          <p:cNvSpPr/>
          <p:nvPr/>
        </p:nvSpPr>
        <p:spPr>
          <a:xfrm>
            <a:off x="30326" y="13717"/>
            <a:ext cx="890385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1200" kern="100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200" kern="100" dirty="0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altLang="ko-KR" sz="1200" kern="1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200" kern="100" dirty="0" smtClean="0">
                <a:latin typeface="Times New Roman"/>
              </a:rPr>
              <a:t>As </a:t>
            </a:r>
            <a:r>
              <a:rPr lang="en-US" altLang="ko-KR" sz="1200" kern="100" dirty="0">
                <a:latin typeface="Times New Roman"/>
              </a:rPr>
              <a:t>a result of the MRM analysis, a list of the 9 proteins where the expression profile of pooling specimen and individual specimen match with each other.</a:t>
            </a:r>
            <a:endParaRPr lang="ko-KR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-2008" y="1494"/>
            <a:ext cx="4173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2.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 binding protein,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anillin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 (ANLN) 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7" name="표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8634787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QSLPVTE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8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3.6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7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9.1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8" name="표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7627593"/>
              </p:ext>
            </p:extLst>
          </p:nvPr>
        </p:nvGraphicFramePr>
        <p:xfrm>
          <a:off x="357158" y="5734061"/>
          <a:ext cx="3927505" cy="733425"/>
        </p:xfrm>
        <a:graphic>
          <a:graphicData uri="http://schemas.openxmlformats.org/drawingml/2006/table">
            <a:tbl>
              <a:tblPr/>
              <a:tblGrid>
                <a:gridCol w="1196964"/>
                <a:gridCol w="39778"/>
                <a:gridCol w="1321916"/>
                <a:gridCol w="1368847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.3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1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5" name="표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5768930"/>
              </p:ext>
            </p:extLst>
          </p:nvPr>
        </p:nvGraphicFramePr>
        <p:xfrm>
          <a:off x="4901483" y="4143380"/>
          <a:ext cx="4016875" cy="1459230"/>
        </p:xfrm>
        <a:graphic>
          <a:graphicData uri="http://schemas.openxmlformats.org/drawingml/2006/table">
            <a:tbl>
              <a:tblPr/>
              <a:tblGrid>
                <a:gridCol w="703687"/>
                <a:gridCol w="1241224"/>
                <a:gridCol w="1062875"/>
                <a:gridCol w="1009089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QSLPVTE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6.2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5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74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5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.88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9.8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4.0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0.7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6" name="표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9580566"/>
              </p:ext>
            </p:extLst>
          </p:nvPr>
        </p:nvGraphicFramePr>
        <p:xfrm>
          <a:off x="4901483" y="5757869"/>
          <a:ext cx="4016875" cy="756285"/>
        </p:xfrm>
        <a:graphic>
          <a:graphicData uri="http://schemas.openxmlformats.org/drawingml/2006/table">
            <a:tbl>
              <a:tblPr/>
              <a:tblGrid>
                <a:gridCol w="1483594"/>
                <a:gridCol w="1323043"/>
                <a:gridCol w="1210238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27" name="직사각형 26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직사각형 27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TextBox 28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5276" y="871256"/>
            <a:ext cx="4113082" cy="3084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64" y="844252"/>
            <a:ext cx="4185090" cy="31388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2546" y="3696485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0146" y="3686210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-2008" y="10120"/>
            <a:ext cx="48013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Brain acid soluble protein 1 (BASP1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2324918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EGAATEEEGTP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07.1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4.84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.6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2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7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.8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5.1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9.1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8333419"/>
              </p:ext>
            </p:extLst>
          </p:nvPr>
        </p:nvGraphicFramePr>
        <p:xfrm>
          <a:off x="357158" y="5734061"/>
          <a:ext cx="3927504" cy="733425"/>
        </p:xfrm>
        <a:graphic>
          <a:graphicData uri="http://schemas.openxmlformats.org/drawingml/2006/table">
            <a:tbl>
              <a:tblPr/>
              <a:tblGrid>
                <a:gridCol w="1051115"/>
                <a:gridCol w="34931"/>
                <a:gridCol w="1328596"/>
                <a:gridCol w="1512862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.8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3829821"/>
              </p:ext>
            </p:extLst>
          </p:nvPr>
        </p:nvGraphicFramePr>
        <p:xfrm>
          <a:off x="4858352" y="4143380"/>
          <a:ext cx="4016877" cy="1459230"/>
        </p:xfrm>
        <a:graphic>
          <a:graphicData uri="http://schemas.openxmlformats.org/drawingml/2006/table">
            <a:tbl>
              <a:tblPr/>
              <a:tblGrid>
                <a:gridCol w="703687"/>
                <a:gridCol w="1241225"/>
                <a:gridCol w="1062876"/>
                <a:gridCol w="1009089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EGAATEEEGTP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4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1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8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.40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2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2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17.0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0.0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68.3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9447526"/>
              </p:ext>
            </p:extLst>
          </p:nvPr>
        </p:nvGraphicFramePr>
        <p:xfrm>
          <a:off x="4858353" y="5757869"/>
          <a:ext cx="4063005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38237"/>
                <a:gridCol w="1224136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No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861340"/>
            <a:ext cx="4130334" cy="30977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663" y="844753"/>
            <a:ext cx="4174565" cy="31309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534" y="3696485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686120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4143892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-2008" y="10120"/>
            <a:ext cx="66479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C-1-tetrahydrofolate synthase, cytoplasmic (MTHFD1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8621826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DTESELDLIS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9.3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4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98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3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.7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0.45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3.8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9800178"/>
              </p:ext>
            </p:extLst>
          </p:nvPr>
        </p:nvGraphicFramePr>
        <p:xfrm>
          <a:off x="357158" y="5734061"/>
          <a:ext cx="3927505" cy="733425"/>
        </p:xfrm>
        <a:graphic>
          <a:graphicData uri="http://schemas.openxmlformats.org/drawingml/2006/table">
            <a:tbl>
              <a:tblPr/>
              <a:tblGrid>
                <a:gridCol w="1196964"/>
                <a:gridCol w="39778"/>
                <a:gridCol w="1321916"/>
                <a:gridCol w="1368847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4.9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7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834632"/>
              </p:ext>
            </p:extLst>
          </p:nvPr>
        </p:nvGraphicFramePr>
        <p:xfrm>
          <a:off x="4841100" y="4143380"/>
          <a:ext cx="4026654" cy="1459230"/>
        </p:xfrm>
        <a:graphic>
          <a:graphicData uri="http://schemas.openxmlformats.org/drawingml/2006/table">
            <a:tbl>
              <a:tblPr/>
              <a:tblGrid>
                <a:gridCol w="705399"/>
                <a:gridCol w="1244246"/>
                <a:gridCol w="1065464"/>
                <a:gridCol w="1011545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DTESELDLIS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85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37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5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9.43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4.2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06.5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8684653"/>
              </p:ext>
            </p:extLst>
          </p:nvPr>
        </p:nvGraphicFramePr>
        <p:xfrm>
          <a:off x="4841101" y="5757869"/>
          <a:ext cx="4063005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38237"/>
                <a:gridCol w="1224136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No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0772" y="829549"/>
            <a:ext cx="4157364" cy="31180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64" y="822386"/>
            <a:ext cx="4176464" cy="3132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675846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675936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4284419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618" y="10120"/>
            <a:ext cx="5724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Calpain-1 catalytic subunit (CAPN1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2748414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LGQDYEQL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0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3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.7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5.00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.79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982697"/>
              </p:ext>
            </p:extLst>
          </p:nvPr>
        </p:nvGraphicFramePr>
        <p:xfrm>
          <a:off x="357157" y="5734061"/>
          <a:ext cx="3927505" cy="733425"/>
        </p:xfrm>
        <a:graphic>
          <a:graphicData uri="http://schemas.openxmlformats.org/drawingml/2006/table">
            <a:tbl>
              <a:tblPr/>
              <a:tblGrid>
                <a:gridCol w="1070750"/>
                <a:gridCol w="35584"/>
                <a:gridCol w="1280483"/>
                <a:gridCol w="1540688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.0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3792113"/>
              </p:ext>
            </p:extLst>
          </p:nvPr>
        </p:nvGraphicFramePr>
        <p:xfrm>
          <a:off x="4815222" y="4143380"/>
          <a:ext cx="4063006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208694"/>
                <a:gridCol w="1035020"/>
                <a:gridCol w="1134048"/>
              </a:tblGrid>
              <a:tr h="428625">
                <a:tc gridSpan="4"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LGQDYEQL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1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7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0.3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6.8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6.6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0795306"/>
              </p:ext>
            </p:extLst>
          </p:nvPr>
        </p:nvGraphicFramePr>
        <p:xfrm>
          <a:off x="4784401" y="5757869"/>
          <a:ext cx="4137971" cy="756285"/>
        </p:xfrm>
        <a:graphic>
          <a:graphicData uri="http://schemas.openxmlformats.org/drawingml/2006/table">
            <a:tbl>
              <a:tblPr/>
              <a:tblGrid>
                <a:gridCol w="1541190"/>
                <a:gridCol w="1374406"/>
                <a:gridCol w="1222375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No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2146" y="840280"/>
            <a:ext cx="4193716" cy="3145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390" y="854343"/>
            <a:ext cx="4156212" cy="3117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686210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706758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2562959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618" y="10120"/>
            <a:ext cx="48013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Complementary C4-A (C4A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9489294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GDTLNLNL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.2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.6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4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5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2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.8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7.34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91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2904881"/>
              </p:ext>
            </p:extLst>
          </p:nvPr>
        </p:nvGraphicFramePr>
        <p:xfrm>
          <a:off x="357158" y="5734061"/>
          <a:ext cx="3926810" cy="733425"/>
        </p:xfrm>
        <a:graphic>
          <a:graphicData uri="http://schemas.openxmlformats.org/drawingml/2006/table">
            <a:tbl>
              <a:tblPr/>
              <a:tblGrid>
                <a:gridCol w="1050929"/>
                <a:gridCol w="34925"/>
                <a:gridCol w="1328788"/>
                <a:gridCol w="1512168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.2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2804900"/>
              </p:ext>
            </p:extLst>
          </p:nvPr>
        </p:nvGraphicFramePr>
        <p:xfrm>
          <a:off x="4816902" y="4143380"/>
          <a:ext cx="4063006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208694"/>
                <a:gridCol w="1035020"/>
                <a:gridCol w="1134048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GDTLNLNL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60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3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0.4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60.7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93.8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3324573"/>
              </p:ext>
            </p:extLst>
          </p:nvPr>
        </p:nvGraphicFramePr>
        <p:xfrm>
          <a:off x="4816903" y="5757869"/>
          <a:ext cx="4063005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38237"/>
                <a:gridCol w="1224136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No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24" y="836712"/>
            <a:ext cx="4156212" cy="31171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390" y="836712"/>
            <a:ext cx="4156212" cy="31171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675937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686210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40304653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618" y="10120"/>
            <a:ext cx="38779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7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Alpha-fetoprotein (AFP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562530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GYQELLE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3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0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58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9.1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1.4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5.23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0377161"/>
              </p:ext>
            </p:extLst>
          </p:nvPr>
        </p:nvGraphicFramePr>
        <p:xfrm>
          <a:off x="357158" y="5734061"/>
          <a:ext cx="3927505" cy="733425"/>
        </p:xfrm>
        <a:graphic>
          <a:graphicData uri="http://schemas.openxmlformats.org/drawingml/2006/table">
            <a:tbl>
              <a:tblPr/>
              <a:tblGrid>
                <a:gridCol w="1196964"/>
                <a:gridCol w="39778"/>
                <a:gridCol w="1321916"/>
                <a:gridCol w="1368847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2.9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0.8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2594074"/>
              </p:ext>
            </p:extLst>
          </p:nvPr>
        </p:nvGraphicFramePr>
        <p:xfrm>
          <a:off x="4832474" y="4143380"/>
          <a:ext cx="4063006" cy="1459230"/>
        </p:xfrm>
        <a:graphic>
          <a:graphicData uri="http://schemas.openxmlformats.org/drawingml/2006/table">
            <a:tbl>
              <a:tblPr/>
              <a:tblGrid>
                <a:gridCol w="711768"/>
                <a:gridCol w="1255479"/>
                <a:gridCol w="1075082"/>
                <a:gridCol w="1020677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GYQELLE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01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30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4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3.4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3.9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1.51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3215493"/>
              </p:ext>
            </p:extLst>
          </p:nvPr>
        </p:nvGraphicFramePr>
        <p:xfrm>
          <a:off x="4801653" y="5757869"/>
          <a:ext cx="4111894" cy="756285"/>
        </p:xfrm>
        <a:graphic>
          <a:graphicData uri="http://schemas.openxmlformats.org/drawingml/2006/table">
            <a:tbl>
              <a:tblPr/>
              <a:tblGrid>
                <a:gridCol w="1527406"/>
                <a:gridCol w="1362113"/>
                <a:gridCol w="1222375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Yes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0772" y="844978"/>
            <a:ext cx="4193716" cy="3145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390" y="854682"/>
            <a:ext cx="4167838" cy="3125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696484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706758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489535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618" y="10120"/>
            <a:ext cx="48013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8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Filamin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-B (FLNB)</a:t>
            </a:r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			</a:t>
            </a: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3739903"/>
              </p:ext>
            </p:extLst>
          </p:nvPr>
        </p:nvGraphicFramePr>
        <p:xfrm>
          <a:off x="357158" y="4143380"/>
          <a:ext cx="3911600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100706"/>
                <a:gridCol w="1071570"/>
                <a:gridCol w="1054080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PLNVQFNSPLPGDAV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28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2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.8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.66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1.72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1980256"/>
              </p:ext>
            </p:extLst>
          </p:nvPr>
        </p:nvGraphicFramePr>
        <p:xfrm>
          <a:off x="357158" y="5734061"/>
          <a:ext cx="3927505" cy="733425"/>
        </p:xfrm>
        <a:graphic>
          <a:graphicData uri="http://schemas.openxmlformats.org/drawingml/2006/table">
            <a:tbl>
              <a:tblPr/>
              <a:tblGrid>
                <a:gridCol w="1196964"/>
                <a:gridCol w="39778"/>
                <a:gridCol w="1321916"/>
                <a:gridCol w="1368847"/>
              </a:tblGrid>
              <a:tr h="381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old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2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.8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1927982"/>
              </p:ext>
            </p:extLst>
          </p:nvPr>
        </p:nvGraphicFramePr>
        <p:xfrm>
          <a:off x="4823848" y="4143380"/>
          <a:ext cx="4063006" cy="1459230"/>
        </p:xfrm>
        <a:graphic>
          <a:graphicData uri="http://schemas.openxmlformats.org/drawingml/2006/table">
            <a:tbl>
              <a:tblPr/>
              <a:tblGrid>
                <a:gridCol w="685244"/>
                <a:gridCol w="1208694"/>
                <a:gridCol w="1035020"/>
                <a:gridCol w="1134048"/>
              </a:tblGrid>
              <a:tr h="42862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PLNVQFNSPLPGDAV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7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</a:t>
                      </a:r>
                    </a:p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reatment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ver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67</a:t>
                      </a:r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40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D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25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19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33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V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48.07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7.86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2.75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8559939"/>
              </p:ext>
            </p:extLst>
          </p:nvPr>
        </p:nvGraphicFramePr>
        <p:xfrm>
          <a:off x="4823849" y="5757869"/>
          <a:ext cx="4063005" cy="756285"/>
        </p:xfrm>
        <a:graphic>
          <a:graphicData uri="http://schemas.openxmlformats.org/drawingml/2006/table">
            <a:tbl>
              <a:tblPr/>
              <a:tblGrid>
                <a:gridCol w="1500632"/>
                <a:gridCol w="1338237"/>
                <a:gridCol w="1224136"/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ealthy control 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vs.</a:t>
                      </a:r>
                    </a:p>
                    <a:p>
                      <a:pPr algn="ctr" fontAlgn="ctr"/>
                      <a:r>
                        <a:rPr lang="en-US" altLang="ko-KR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HCC treatment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Befor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vs.</a:t>
                      </a:r>
                      <a:endParaRPr lang="en-US" sz="800" b="1" i="0" u="none" strike="noStrike" baseline="0" dirty="0" smtClean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 fontAlgn="ctr"/>
                      <a:r>
                        <a:rPr lang="en-US" sz="8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fter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HCC treatmen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524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Meaningful difference</a:t>
                      </a:r>
                    </a:p>
                    <a:p>
                      <a:pPr algn="ctr" fontAlgn="ctr"/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( </a:t>
                      </a:r>
                      <a:r>
                        <a:rPr lang="en-US" sz="1200" b="1" i="1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&lt;  0.05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 </a:t>
                      </a:r>
                      <a:r>
                        <a:rPr lang="en-US" altLang="ko-KR" sz="1200" b="1" i="0" u="none" strike="noStrike" kern="1200" dirty="0" smtClean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+mn-cs"/>
                        </a:rPr>
                        <a:t>No</a:t>
                      </a:r>
                      <a:endParaRPr lang="ko-KR" altLang="en-US" sz="1200" b="1" i="0" u="none" strike="noStrike" kern="1200" dirty="0" smtClean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" name="직사각형 12"/>
          <p:cNvSpPr/>
          <p:nvPr/>
        </p:nvSpPr>
        <p:spPr>
          <a:xfrm>
            <a:off x="142844" y="714356"/>
            <a:ext cx="4286280" cy="59293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4714876" y="714356"/>
            <a:ext cx="4286280" cy="59293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1500166" y="571480"/>
            <a:ext cx="171451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ooled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00760" y="571480"/>
            <a:ext cx="207170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dividual serum</a:t>
            </a:r>
            <a:endParaRPr lang="ko-KR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0772" y="851337"/>
            <a:ext cx="4193716" cy="3145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389" y="861040"/>
            <a:ext cx="4167839" cy="31258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820" y="3706759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9872" y="3717032"/>
            <a:ext cx="2689464" cy="3926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898035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5</TotalTime>
  <Words>942</Words>
  <Application>Microsoft Office PowerPoint</Application>
  <PresentationFormat>화면 슬라이드 쇼(4:3)</PresentationFormat>
  <Paragraphs>551</Paragraphs>
  <Slides>10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1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WinX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WinXP</dc:creator>
  <cp:lastModifiedBy>samsung</cp:lastModifiedBy>
  <cp:revision>94</cp:revision>
  <dcterms:created xsi:type="dcterms:W3CDTF">2012-11-22T02:06:50Z</dcterms:created>
  <dcterms:modified xsi:type="dcterms:W3CDTF">2013-04-10T03:47:43Z</dcterms:modified>
</cp:coreProperties>
</file>